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5" d="100"/>
          <a:sy n="85" d="100"/>
        </p:scale>
        <p:origin x="72" y="5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92915E-06B6-440C-8960-AC4D3F84E1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B0D2E0-DF80-431E-9DCA-10547493A5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2C4284-A2A3-466A-B2F6-945C059F5F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D2E669-4BAC-4EEE-86D1-E4206396DA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49D0ED-FE42-46F4-9BDA-51E472468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979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259A3E-5D05-44E2-98A5-F1CC64F5F7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390661-82D6-4CA0-8851-E05AA7F53C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0776E4-A090-4FC9-8FC0-0D79F8AFC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EE57B4-F865-4027-B8E6-EB5B57D0A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CFA783-9B84-447F-8FC0-47EA36257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490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FC9D2E-FE72-48A6-A500-4A1AAAE12C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2BE664-D819-4A2D-B798-42D9908237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5661AA-074D-420F-A8D1-A353370E07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27773A-EE7B-4257-AA8E-D0AD9E612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4E57D0-8531-45AE-B518-E070F9FBD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139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D7073-EBD7-4118-9E84-8D3286803B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0BF563-B416-4DA6-8678-398F03E97E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EB7E6C-1555-40B6-9E7F-206B2196B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E02AB9-9BE9-4C5D-B6B6-FB122A0DB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EBEE73-52CF-409D-BF73-430E0B94E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740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69674-3200-4CF7-AD66-2085A4B87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E551B8-96A1-40FF-819F-77CB43EBCF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8C9B6C-BE8A-409D-8585-860972268B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AB358D-D802-4425-B995-2EA736AEC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D77D37-3928-49B9-B841-E35676C3E8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357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96EFDA-70C6-436E-B3F0-D3CA9E2D1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D0118D-4C54-4AB7-A065-D51C3E4686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C11018-0926-4341-9706-5A62465C86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862364-D216-4136-849D-D23925828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1972DC-A558-4406-9B16-BFF685502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0A64BB-04E7-4C91-A598-31957C06F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691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FB81B-5A50-466B-825A-62B6EAFC23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87133B-6441-4395-8239-E8A2E24861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F6E624-02B3-462B-B5B0-D36A785A25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670390-EE47-47B3-94FA-926FBCD084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26F5B1-E23B-4895-A739-47961964C0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421EA1-BF32-4A9E-8B48-777F53650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333AFBF-55B5-470A-A2DA-D110D9698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018A68-A35B-4515-9A98-B3DE9E491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832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56D303-511F-4F44-A6CD-2659041FAB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1B69F8-9147-452A-A74E-DA8882ACB5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84C8BA-D15B-42A7-B562-740723DF4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DC2520-8D02-44D8-B4A6-26C7E3687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077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8F26392-265E-43C0-A693-E1D0E517A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216EF5-0CB0-401F-8D96-C22EB51A2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62DB9E-2F48-46A0-B631-B739C8AB7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913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4A723-96CB-4E18-AC9D-D380261A81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8526DB-A4C5-445C-A41D-8D13CFE44D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D73C27-7857-4AC7-B840-39B91C6EF4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EE812C-3FF0-4E8C-BF66-AEFC9AC83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7AE77C-A557-4522-BAB9-F77BA6D1D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F10E20-9BB1-4990-A404-64FCF2E99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27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D1D338-2DB7-4290-8B99-525A052B48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373B4F-CA96-4A60-8097-CD40DE3482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93069E-F76B-43D0-BD4C-DD1F5DFCC6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1E2571-3C7C-4D7B-8D39-C39911AD3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02D97A-4F25-40B3-88E5-CD84E6BE02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9EC1FB-802B-4927-988F-44ED373B1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211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F81ECC-6924-4032-B74D-EF5B6FF68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B4B389-9261-4D60-B9A8-D71E927F0C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CAA4F2-5785-44A7-BDBC-9E297FEC71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FAAE2E-8FEB-460D-8920-8A52A5273765}" type="datetimeFigureOut">
              <a:rPr lang="en-US" smtClean="0"/>
              <a:t>7/1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37532F-079A-49D2-B01F-96F9D61828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DD9EE5-AB89-491D-BD2E-728C793F93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E6891-9271-4164-B774-6E37C2BE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852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map with text&#10;&#10;Description automatically generated">
            <a:extLst>
              <a:ext uri="{FF2B5EF4-FFF2-40B4-BE49-F238E27FC236}">
                <a16:creationId xmlns:a16="http://schemas.microsoft.com/office/drawing/2014/main" id="{6A70CC14-587F-432D-8B7F-37BA805B76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0698" y="961903"/>
            <a:ext cx="6400800" cy="29108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24B75C8-83C1-4B33-AB65-2455B88D766B}"/>
              </a:ext>
            </a:extLst>
          </p:cNvPr>
          <p:cNvSpPr txBox="1"/>
          <p:nvPr/>
        </p:nvSpPr>
        <p:spPr>
          <a:xfrm>
            <a:off x="2902830" y="3872743"/>
            <a:ext cx="63863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Flow cytometry gating strategy for innate immune cell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L samples were centrifuged and the cellular fraction was stained with for surface or intracellular markers with fluorochrome-conjugated antibodies as described in Materials and Methods. Samples were run on a B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SRFortess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low cytometry machine and data was analyz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owJ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gating strategy to identify neutrophils, alveolar macrophages, eosinophils, and monocytes are illustrated here in red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83951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video game&#10;&#10;Description automatically generated">
            <a:extLst>
              <a:ext uri="{FF2B5EF4-FFF2-40B4-BE49-F238E27FC236}">
                <a16:creationId xmlns:a16="http://schemas.microsoft.com/office/drawing/2014/main" id="{82D69AFC-4F32-48FA-8A35-80891B63D5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9400" y="1126998"/>
            <a:ext cx="6400800" cy="296570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42108B8-2C15-476A-B8DC-E590831041D5}"/>
              </a:ext>
            </a:extLst>
          </p:cNvPr>
          <p:cNvSpPr txBox="1"/>
          <p:nvPr/>
        </p:nvSpPr>
        <p:spPr>
          <a:xfrm>
            <a:off x="2971800" y="4092702"/>
            <a:ext cx="606249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Flow cytometry gating strategy for T lymphocyt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L or lung homogenate samples were centrifuged and the cellular fraction was stained with for surface or intracellular markers with fluorochrome-conjugated antibodies as described in Materials and Methods. Samples were run on a B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SRFortess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low cytometry machine and data was analyz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owJ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gating strategy to identify CD4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 cells and CD8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 cells are illustrated here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9371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map&#10;&#10;Description automatically generated">
            <a:extLst>
              <a:ext uri="{FF2B5EF4-FFF2-40B4-BE49-F238E27FC236}">
                <a16:creationId xmlns:a16="http://schemas.microsoft.com/office/drawing/2014/main" id="{F6EE8E59-BEA4-4274-B21F-C6377B0BBF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600" y="1252728"/>
            <a:ext cx="6400800" cy="435254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AAF8539-F038-473B-BFA7-FD1A45D24661}"/>
              </a:ext>
            </a:extLst>
          </p:cNvPr>
          <p:cNvSpPr txBox="1"/>
          <p:nvPr/>
        </p:nvSpPr>
        <p:spPr>
          <a:xfrm>
            <a:off x="3076575" y="2749677"/>
            <a:ext cx="31242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Flow cytometry gating strategy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or ILC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ung homogenate samples were centrifuged and the cellular fraction was stained with for surface or intracellular markers with fluorochrome-conjugated antibodies as described in Materials and Methods. Samples were run on a B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SRFortess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low cytometry machine and data was analyzed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owJ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gating strategy to identify ILC2s are illustrated here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8004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17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ry Empey</dc:creator>
  <cp:lastModifiedBy>Kerry Empey</cp:lastModifiedBy>
  <cp:revision>4</cp:revision>
  <dcterms:created xsi:type="dcterms:W3CDTF">2020-06-19T10:08:47Z</dcterms:created>
  <dcterms:modified xsi:type="dcterms:W3CDTF">2020-07-16T01:08:18Z</dcterms:modified>
</cp:coreProperties>
</file>